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4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0234;&#22338;&#12288;&#21746;&#21705;\Desktop\&#31070;&#22856;&#24029;&#30476;&#31435;&#12364;&#12435;&#12475;&#12531;&#12479;&#12540;\&#30382;&#19979;&#33026;&#32938;&#12539;&#20869;&#33235;&#33026;&#32938;\&#35542;&#25991;\JCSM\ReRevise\cut%20off%20H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0234;&#22338;&#12288;&#21746;&#21705;\Desktop\&#31070;&#22856;&#24029;&#30476;&#31435;&#12364;&#12435;&#12475;&#12531;&#12479;&#12540;\&#30382;&#19979;&#33026;&#32938;&#12539;&#20869;&#33235;&#33026;&#32938;\&#35542;&#25991;\JCSM\ReRevise\cut%20off%20HR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VFA!$B$15:$U$15</c:f>
                <c:numCache>
                  <c:formatCode>General</c:formatCode>
                  <c:ptCount val="20"/>
                  <c:pt idx="0">
                    <c:v>1.9469000000000003</c:v>
                  </c:pt>
                  <c:pt idx="1">
                    <c:v>2.2319</c:v>
                  </c:pt>
                  <c:pt idx="2">
                    <c:v>2.4740000000000002</c:v>
                  </c:pt>
                  <c:pt idx="3">
                    <c:v>2.9470000000000001</c:v>
                  </c:pt>
                  <c:pt idx="4">
                    <c:v>3.4990000000000001</c:v>
                  </c:pt>
                  <c:pt idx="5">
                    <c:v>3.5790000000000002</c:v>
                  </c:pt>
                  <c:pt idx="6">
                    <c:v>2.8229999999999995</c:v>
                  </c:pt>
                  <c:pt idx="7">
                    <c:v>2.9689999999999999</c:v>
                  </c:pt>
                  <c:pt idx="8">
                    <c:v>3.4240000000000004</c:v>
                  </c:pt>
                  <c:pt idx="9">
                    <c:v>3.9560000000000004</c:v>
                  </c:pt>
                  <c:pt idx="10">
                    <c:v>4.6959999999999997</c:v>
                  </c:pt>
                  <c:pt idx="11">
                    <c:v>5.4829999999999988</c:v>
                  </c:pt>
                  <c:pt idx="12">
                    <c:v>6.5719999999999992</c:v>
                  </c:pt>
                  <c:pt idx="13">
                    <c:v>7.3609999999999989</c:v>
                  </c:pt>
                  <c:pt idx="14">
                    <c:v>4.2850000000000001</c:v>
                  </c:pt>
                  <c:pt idx="15">
                    <c:v>4.7210000000000001</c:v>
                  </c:pt>
                  <c:pt idx="16">
                    <c:v>5.1459999999999999</c:v>
                  </c:pt>
                </c:numCache>
              </c:numRef>
            </c:plus>
            <c:minus>
              <c:numRef>
                <c:f>VFA!$B$12:$U$12</c:f>
                <c:numCache>
                  <c:formatCode>General</c:formatCode>
                  <c:ptCount val="20"/>
                  <c:pt idx="0">
                    <c:v>0.59939999999999993</c:v>
                  </c:pt>
                  <c:pt idx="1">
                    <c:v>0.68730000000000002</c:v>
                  </c:pt>
                  <c:pt idx="2">
                    <c:v>0.76200000000000001</c:v>
                  </c:pt>
                  <c:pt idx="3">
                    <c:v>0.90810000000000013</c:v>
                  </c:pt>
                  <c:pt idx="4">
                    <c:v>1.0774999999999999</c:v>
                  </c:pt>
                  <c:pt idx="5">
                    <c:v>1.1017000000000001</c:v>
                  </c:pt>
                  <c:pt idx="6">
                    <c:v>0.92399999999999993</c:v>
                  </c:pt>
                  <c:pt idx="7">
                    <c:v>0.97080000000000011</c:v>
                  </c:pt>
                  <c:pt idx="8">
                    <c:v>1.1194999999999999</c:v>
                  </c:pt>
                  <c:pt idx="9">
                    <c:v>1.2911999999999999</c:v>
                  </c:pt>
                  <c:pt idx="10">
                    <c:v>1.5362999999999998</c:v>
                  </c:pt>
                  <c:pt idx="11">
                    <c:v>1.7940999999999998</c:v>
                  </c:pt>
                  <c:pt idx="12">
                    <c:v>2.15</c:v>
                  </c:pt>
                  <c:pt idx="13">
                    <c:v>2.4090000000000003</c:v>
                  </c:pt>
                  <c:pt idx="14">
                    <c:v>1.4395000000000002</c:v>
                  </c:pt>
                  <c:pt idx="15">
                    <c:v>1.5862999999999998</c:v>
                  </c:pt>
                  <c:pt idx="16">
                    <c:v>1.7289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VFA!$B$9:$U$9</c:f>
              <c:numCache>
                <c:formatCode>General</c:formatCode>
                <c:ptCount val="20"/>
                <c:pt idx="0">
                  <c:v>13</c:v>
                </c:pt>
                <c:pt idx="1">
                  <c:v>11</c:v>
                </c:pt>
                <c:pt idx="2">
                  <c:v>9</c:v>
                </c:pt>
                <c:pt idx="3">
                  <c:v>7</c:v>
                </c:pt>
                <c:pt idx="4">
                  <c:v>5</c:v>
                </c:pt>
                <c:pt idx="5">
                  <c:v>3</c:v>
                </c:pt>
                <c:pt idx="6">
                  <c:v>1</c:v>
                </c:pt>
                <c:pt idx="7">
                  <c:v>-1</c:v>
                </c:pt>
                <c:pt idx="8">
                  <c:v>-3</c:v>
                </c:pt>
                <c:pt idx="9">
                  <c:v>-5</c:v>
                </c:pt>
                <c:pt idx="10">
                  <c:v>-7</c:v>
                </c:pt>
                <c:pt idx="11">
                  <c:v>-9</c:v>
                </c:pt>
                <c:pt idx="12">
                  <c:v>-11</c:v>
                </c:pt>
                <c:pt idx="13">
                  <c:v>-13</c:v>
                </c:pt>
                <c:pt idx="14">
                  <c:v>-15</c:v>
                </c:pt>
                <c:pt idx="15">
                  <c:v>-17</c:v>
                </c:pt>
                <c:pt idx="16">
                  <c:v>-19</c:v>
                </c:pt>
              </c:numCache>
            </c:numRef>
          </c:xVal>
          <c:yVal>
            <c:numRef>
              <c:f>VFA!$B$10:$U$10</c:f>
              <c:numCache>
                <c:formatCode>General</c:formatCode>
                <c:ptCount val="20"/>
                <c:pt idx="0">
                  <c:v>0.86609999999999998</c:v>
                </c:pt>
                <c:pt idx="1">
                  <c:v>0.99309999999999998</c:v>
                </c:pt>
                <c:pt idx="2">
                  <c:v>1.101</c:v>
                </c:pt>
                <c:pt idx="3">
                  <c:v>1.3120000000000001</c:v>
                </c:pt>
                <c:pt idx="4">
                  <c:v>1.5569999999999999</c:v>
                </c:pt>
                <c:pt idx="5">
                  <c:v>1.5920000000000001</c:v>
                </c:pt>
                <c:pt idx="6">
                  <c:v>1.373</c:v>
                </c:pt>
                <c:pt idx="7">
                  <c:v>1.4430000000000001</c:v>
                </c:pt>
                <c:pt idx="8">
                  <c:v>1.6639999999999999</c:v>
                </c:pt>
                <c:pt idx="9">
                  <c:v>1.92</c:v>
                </c:pt>
                <c:pt idx="10">
                  <c:v>2.2829999999999999</c:v>
                </c:pt>
                <c:pt idx="11">
                  <c:v>2.6659999999999999</c:v>
                </c:pt>
                <c:pt idx="12">
                  <c:v>3.1949999999999998</c:v>
                </c:pt>
                <c:pt idx="13">
                  <c:v>3.5790000000000002</c:v>
                </c:pt>
                <c:pt idx="14">
                  <c:v>2.1680000000000001</c:v>
                </c:pt>
                <c:pt idx="15">
                  <c:v>2.3889999999999998</c:v>
                </c:pt>
                <c:pt idx="16">
                  <c:v>2.604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C63-4EE2-841D-1A6E913571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28954624"/>
        <c:axId val="1128954144"/>
      </c:scatterChart>
      <c:valAx>
        <c:axId val="1128954624"/>
        <c:scaling>
          <c:orientation val="maxMin"/>
          <c:max val="15"/>
          <c:min val="-19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</a:rPr>
                  <a:t>Cutoff point of VFA change at POY3</a:t>
                </a:r>
                <a:endParaRPr lang="ja-JP" sz="16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2500748838790296"/>
              <c:y val="0.924088993909634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alpha val="99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128954144"/>
        <c:crossesAt val="0.125"/>
        <c:crossBetween val="midCat"/>
        <c:majorUnit val="2"/>
      </c:valAx>
      <c:valAx>
        <c:axId val="1128954144"/>
        <c:scaling>
          <c:logBase val="2"/>
          <c:orientation val="minMax"/>
          <c:max val="25"/>
          <c:min val="0.12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</a:rPr>
                  <a:t>HR (95% CI)</a:t>
                </a:r>
                <a:endParaRPr lang="ja-JP" sz="16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7.3961783305951942E-3"/>
              <c:y val="0.285849990712926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128954624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WC!$F$14:$U$14</c:f>
                <c:numCache>
                  <c:formatCode>General</c:formatCode>
                  <c:ptCount val="16"/>
                  <c:pt idx="1">
                    <c:v>1.5037000000000003</c:v>
                  </c:pt>
                  <c:pt idx="2">
                    <c:v>2.1009000000000002</c:v>
                  </c:pt>
                  <c:pt idx="3">
                    <c:v>1.8554000000000002</c:v>
                  </c:pt>
                  <c:pt idx="4">
                    <c:v>2.4930000000000003</c:v>
                  </c:pt>
                  <c:pt idx="5">
                    <c:v>3.7519999999999998</c:v>
                  </c:pt>
                  <c:pt idx="6">
                    <c:v>5.2710000000000008</c:v>
                  </c:pt>
                  <c:pt idx="7">
                    <c:v>5.5859999999999994</c:v>
                  </c:pt>
                  <c:pt idx="8">
                    <c:v>4.4609999999999994</c:v>
                  </c:pt>
                  <c:pt idx="9">
                    <c:v>5.5380000000000003</c:v>
                  </c:pt>
                  <c:pt idx="10">
                    <c:v>7.8599999999999994</c:v>
                  </c:pt>
                  <c:pt idx="11">
                    <c:v>8.3470000000000013</c:v>
                  </c:pt>
                  <c:pt idx="12">
                    <c:v>8.7210000000000001</c:v>
                  </c:pt>
                  <c:pt idx="13">
                    <c:v>9.0299999999999994</c:v>
                  </c:pt>
                </c:numCache>
              </c:numRef>
            </c:plus>
            <c:minus>
              <c:numRef>
                <c:f>WC!$F$12:$U$12</c:f>
                <c:numCache>
                  <c:formatCode>General</c:formatCode>
                  <c:ptCount val="16"/>
                  <c:pt idx="1">
                    <c:v>0.4627</c:v>
                  </c:pt>
                  <c:pt idx="2">
                    <c:v>0.64660000000000006</c:v>
                  </c:pt>
                  <c:pt idx="3">
                    <c:v>0.60670000000000002</c:v>
                  </c:pt>
                  <c:pt idx="4">
                    <c:v>0.81510000000000016</c:v>
                  </c:pt>
                  <c:pt idx="5">
                    <c:v>1.2262</c:v>
                  </c:pt>
                  <c:pt idx="6">
                    <c:v>1.7242999999999999</c:v>
                  </c:pt>
                  <c:pt idx="7">
                    <c:v>1.8764000000000003</c:v>
                  </c:pt>
                  <c:pt idx="8">
                    <c:v>1.4592000000000001</c:v>
                  </c:pt>
                  <c:pt idx="9">
                    <c:v>1.8104</c:v>
                  </c:pt>
                  <c:pt idx="10">
                    <c:v>2.5709999999999997</c:v>
                  </c:pt>
                  <c:pt idx="11">
                    <c:v>2.5700000000000003</c:v>
                  </c:pt>
                  <c:pt idx="12">
                    <c:v>2.3988</c:v>
                  </c:pt>
                  <c:pt idx="13">
                    <c:v>2.0004999999999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WC!$F$9:$U$9</c:f>
              <c:numCache>
                <c:formatCode>General</c:formatCode>
                <c:ptCount val="16"/>
                <c:pt idx="1">
                  <c:v>4</c:v>
                </c:pt>
                <c:pt idx="2">
                  <c:v>3</c:v>
                </c:pt>
                <c:pt idx="3">
                  <c:v>2</c:v>
                </c:pt>
                <c:pt idx="4">
                  <c:v>1</c:v>
                </c:pt>
                <c:pt idx="5">
                  <c:v>0</c:v>
                </c:pt>
                <c:pt idx="6">
                  <c:v>-1</c:v>
                </c:pt>
                <c:pt idx="7">
                  <c:v>-2</c:v>
                </c:pt>
                <c:pt idx="8">
                  <c:v>-3</c:v>
                </c:pt>
                <c:pt idx="9">
                  <c:v>-4</c:v>
                </c:pt>
                <c:pt idx="10">
                  <c:v>-5</c:v>
                </c:pt>
                <c:pt idx="11">
                  <c:v>-6</c:v>
                </c:pt>
                <c:pt idx="12">
                  <c:v>-7</c:v>
                </c:pt>
                <c:pt idx="13">
                  <c:v>-8</c:v>
                </c:pt>
              </c:numCache>
            </c:numRef>
          </c:xVal>
          <c:yVal>
            <c:numRef>
              <c:f>WC!$F$10:$U$10</c:f>
              <c:numCache>
                <c:formatCode>General</c:formatCode>
                <c:ptCount val="16"/>
                <c:pt idx="1">
                  <c:v>0.66830000000000001</c:v>
                </c:pt>
                <c:pt idx="2">
                  <c:v>0.93410000000000004</c:v>
                </c:pt>
                <c:pt idx="3">
                  <c:v>0.90159999999999996</c:v>
                </c:pt>
                <c:pt idx="4">
                  <c:v>1.2110000000000001</c:v>
                </c:pt>
                <c:pt idx="5">
                  <c:v>1.8220000000000001</c:v>
                </c:pt>
                <c:pt idx="6">
                  <c:v>2.5619999999999998</c:v>
                </c:pt>
                <c:pt idx="7">
                  <c:v>2.8250000000000002</c:v>
                </c:pt>
                <c:pt idx="8">
                  <c:v>2.1680000000000001</c:v>
                </c:pt>
                <c:pt idx="9">
                  <c:v>2.69</c:v>
                </c:pt>
                <c:pt idx="10">
                  <c:v>3.82</c:v>
                </c:pt>
                <c:pt idx="11">
                  <c:v>3.7130000000000001</c:v>
                </c:pt>
                <c:pt idx="12">
                  <c:v>3.3090000000000002</c:v>
                </c:pt>
                <c:pt idx="13">
                  <c:v>2.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D99-492A-B1A9-E50C8738DC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28954624"/>
        <c:axId val="1128954144"/>
      </c:scatterChart>
      <c:valAx>
        <c:axId val="1128954624"/>
        <c:scaling>
          <c:orientation val="maxMin"/>
          <c:max val="5"/>
          <c:min val="-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</a:rPr>
                  <a:t>Cutoff point of </a:t>
                </a:r>
                <a:r>
                  <a:rPr lang="en-US" altLang="ja-JP" sz="1600" dirty="0">
                    <a:solidFill>
                      <a:schemeClr val="tx1"/>
                    </a:solidFill>
                  </a:rPr>
                  <a:t>WC</a:t>
                </a:r>
                <a:r>
                  <a:rPr lang="en-US" sz="1600" dirty="0">
                    <a:solidFill>
                      <a:schemeClr val="tx1"/>
                    </a:solidFill>
                  </a:rPr>
                  <a:t> change at POY3</a:t>
                </a:r>
                <a:endParaRPr lang="ja-JP" sz="16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21127033442089641"/>
              <c:y val="0.92408899390963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ctr" rtl="0"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alpha val="99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128954144"/>
        <c:crossesAt val="0.125"/>
        <c:crossBetween val="midCat"/>
        <c:majorUnit val="1"/>
      </c:valAx>
      <c:valAx>
        <c:axId val="1128954144"/>
        <c:scaling>
          <c:logBase val="2"/>
          <c:orientation val="minMax"/>
          <c:max val="25"/>
          <c:min val="0.12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600" b="0" i="0" u="none" strike="noStrike" kern="12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R (95% CI)</a:t>
                </a:r>
                <a:endParaRPr lang="ja-JP" altLang="ja-JP" sz="1600" b="0" i="0" u="none" strike="noStrike" kern="1200" baseline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0698031835910725E-2"/>
              <c:y val="0.277363141349265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128954624"/>
        <c:crosses val="max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8682</cdr:x>
      <cdr:y>0.5032</cdr:y>
    </cdr:from>
    <cdr:to>
      <cdr:x>0.96011</cdr:x>
      <cdr:y>0.50598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1F0C4B47-2F86-10E7-B452-9755296C85A0}"/>
            </a:ext>
          </a:extLst>
        </cdr:cNvPr>
        <cdr:cNvCxnSpPr/>
      </cdr:nvCxnSpPr>
      <cdr:spPr>
        <a:xfrm xmlns:a="http://schemas.openxmlformats.org/drawingml/2006/main" flipV="1">
          <a:off x="887101" y="1801596"/>
          <a:ext cx="3672000" cy="9953"/>
        </a:xfrm>
        <a:prstGeom xmlns:a="http://schemas.openxmlformats.org/drawingml/2006/main" prst="line">
          <a:avLst/>
        </a:prstGeom>
        <a:ln xmlns:a="http://schemas.openxmlformats.org/drawingml/2006/main" w="6350">
          <a:solidFill>
            <a:schemeClr val="bg1">
              <a:lumMod val="6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9E53CF-93F3-4607-A796-AFA64E70C880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DD87FF-D22E-45A5-8F4E-683D90CDC1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4552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DD87FF-D22E-45A5-8F4E-683D90CDC12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6824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476F72-FFC8-E6F9-AF39-649186BC1F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BCC00A8-3705-03DC-821D-C9A5DA3B1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E495C6-A285-9725-C4E5-FB72D2E6D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8361A5-B7A4-CA18-9441-3C211E23B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FFEAC3-7CE4-855D-2B4F-D00385518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1704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7A35EB-F8BE-61A4-4E9B-FBCC1DEA8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822061E-A627-9A45-C718-021008F00F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EB0ECA-2A7A-D098-168E-93BE8254C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792042-78BD-7028-4F29-3DFB6E60E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78A152-CD5F-32B8-28F5-3D48F0395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4006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5E1F010-D019-A35B-F93B-9B7E692240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921F2B5-55F2-A58E-22A1-AB24AA7AB1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E5B30C2-D26D-28A3-E9B9-06ABAF5C18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254813-3AA4-8762-8C8C-CB0858B78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44D5F1-C115-15ED-15E3-B5B04C324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765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783A5F-3BE3-D810-3BBD-1610A60F0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FD4FE35-9DE0-D6F3-50DE-3A01A84D52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EC0D86-68C9-D55D-5C0D-2FACCB602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EF33CE-0D06-27B3-B577-6AC72F645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017C37-84A5-8D6D-2A67-C902EDA15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9239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D73A59-F1FF-DF2D-46A5-A1EC7ECD3B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F265BF9-3E4D-3E3F-8AF5-2A8085C103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E55685-D7FB-F527-B391-E593C8AA78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B7FE1F-75B5-0207-2DDD-A254A5602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31DB0F-407F-5406-5A50-2DD1AFF7F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8086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6EE52B-8F3F-6E5F-C3ED-E6C9913423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47E4FDE-CAA3-DB76-97FE-8559A1E7E1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FEF7CFE-E266-208D-DB99-71D7CED0DA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0118C30-6F90-220D-1A76-5C19A5A58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44AD7B-94A0-58A1-3652-AB5C2F91CB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7B23289-34B1-0C1F-2EBB-6FDEC1724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4318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CFBC65-C436-4328-8B0F-D97BD8012A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CBEC1D7-56C9-CE31-32A3-0C15E7206B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63B7AE6-7B78-78B9-33D5-8DD17DF413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61150D0-969B-7A1B-39CF-D17393F479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05D60BE-1004-2C24-22EF-68B72940E8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F740396-9211-900C-E944-018358159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8F8D040-16BC-C8EA-3C3F-DF57DDD11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172DCA9-3C9B-6756-5C5D-438957511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523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83AEF6-0CDD-AD3B-3770-9B283BEF4E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DE3E00E-ED67-3751-D226-F52D44A12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95DA58E-2C34-F8A5-3ADF-CA7C3683F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5092F0E-6B65-9D93-6EFC-B775C8196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055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4CE58B1-5A98-7CB0-E704-60481BD9F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6DF119E-7F71-AF5D-A947-5E3539FBC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B096D76-F9B9-8E9B-693B-2D937904F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9687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AEEA55-A768-DE49-EEB0-D61DC9ED01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1DB0EB-4EF0-FAF1-AC5E-B6B1D70A43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25307F4-5037-92E8-6025-F0A24E8620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020400B-4A39-BD8E-BC9B-B33755F837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04098D-AC98-250E-34CC-878895D28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11528E8-FB56-D5D3-E8D9-611A3D2ED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1605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85C55A-0F85-AFB3-2DEF-8E2DFA1A6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2580289-12E3-C250-5D17-F8B72BDAB6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D9158B7-1CB7-509E-D74B-DB0F629142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1E98BB-EB34-0A4A-42F9-AC8A0F18B6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426D478-E16A-8C7C-0FC2-BC914C0111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F442D41-DFE8-C13F-4EC1-BACB5C577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6559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ADBDD6F-EF74-D8D2-340C-A7FA08EEE0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33C8BD7-6FEF-F180-9D7E-55B1C09DF0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F11772-6DED-6FBA-452E-8AB5D96419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7964E8-D0DE-4915-B60A-ADE2B59559A8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084971F-8221-2717-1C17-8735F51BC4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122B99-ECF7-AA34-E165-C9183F7AA2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9B52D2-8426-4D0F-9760-F3E64D3CDC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4429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EE7363-A660-5ADB-05E2-0F18F78A63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6308" y="-31323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ja-JP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ゴシック" panose="020B0609070205080204" pitchFamily="49" charset="-128"/>
              </a:rPr>
              <a:t>Supplementary Figure 4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705533F9-DCDF-487D-B138-1A379A8BA1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8345745"/>
              </p:ext>
            </p:extLst>
          </p:nvPr>
        </p:nvGraphicFramePr>
        <p:xfrm>
          <a:off x="362799" y="2503055"/>
          <a:ext cx="5151309" cy="35802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1A398E0-8854-DF77-DD4F-982D428404AA}"/>
              </a:ext>
            </a:extLst>
          </p:cNvPr>
          <p:cNvSpPr txBox="1"/>
          <p:nvPr/>
        </p:nvSpPr>
        <p:spPr>
          <a:xfrm>
            <a:off x="4194414" y="4375535"/>
            <a:ext cx="726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F363A55-0FA8-4A86-05C7-1E0E8DC6AC6B}"/>
              </a:ext>
            </a:extLst>
          </p:cNvPr>
          <p:cNvSpPr txBox="1"/>
          <p:nvPr/>
        </p:nvSpPr>
        <p:spPr>
          <a:xfrm>
            <a:off x="4419181" y="4375535"/>
            <a:ext cx="726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0AE94E89-C4F8-D168-215A-C79FDAB010AB}"/>
              </a:ext>
            </a:extLst>
          </p:cNvPr>
          <p:cNvCxnSpPr/>
          <p:nvPr/>
        </p:nvCxnSpPr>
        <p:spPr>
          <a:xfrm flipV="1">
            <a:off x="1184914" y="4305600"/>
            <a:ext cx="4104000" cy="9092"/>
          </a:xfrm>
          <a:prstGeom prst="line">
            <a:avLst/>
          </a:prstGeom>
          <a:ln w="63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13D984F-669A-5F23-B2FE-0DC36D86F426}"/>
              </a:ext>
            </a:extLst>
          </p:cNvPr>
          <p:cNvSpPr txBox="1"/>
          <p:nvPr/>
        </p:nvSpPr>
        <p:spPr>
          <a:xfrm>
            <a:off x="3819895" y="4935607"/>
            <a:ext cx="11985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&lt;0.0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BFE953C-9D25-D2B6-3D51-21107D0C0662}"/>
              </a:ext>
            </a:extLst>
          </p:cNvPr>
          <p:cNvSpPr txBox="1"/>
          <p:nvPr/>
        </p:nvSpPr>
        <p:spPr>
          <a:xfrm>
            <a:off x="9524119" y="4357307"/>
            <a:ext cx="726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2E7CE1E-97B4-3DDD-49DD-0D3AAE527AEE}"/>
              </a:ext>
            </a:extLst>
          </p:cNvPr>
          <p:cNvSpPr txBox="1"/>
          <p:nvPr/>
        </p:nvSpPr>
        <p:spPr>
          <a:xfrm>
            <a:off x="9811783" y="4357307"/>
            <a:ext cx="726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2E1DC1F-5BBC-41AB-7C0F-1BD1B0CEBEF9}"/>
              </a:ext>
            </a:extLst>
          </p:cNvPr>
          <p:cNvSpPr txBox="1"/>
          <p:nvPr/>
        </p:nvSpPr>
        <p:spPr>
          <a:xfrm>
            <a:off x="9500309" y="4957951"/>
            <a:ext cx="11985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P&lt;0.0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5FB064F-0047-588E-FD3D-272E2EEF2FC1}"/>
              </a:ext>
            </a:extLst>
          </p:cNvPr>
          <p:cNvSpPr txBox="1"/>
          <p:nvPr/>
        </p:nvSpPr>
        <p:spPr>
          <a:xfrm>
            <a:off x="1957560" y="1222972"/>
            <a:ext cx="25587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+mj-cs"/>
              </a:rPr>
              <a:t>VFA change at POY3</a:t>
            </a:r>
            <a:endParaRPr lang="ja-JP" altLang="en-US" sz="2000" b="1" kern="0" dirty="0" err="1">
              <a:solidFill>
                <a:srgbClr val="000000"/>
              </a:solidFill>
              <a:latin typeface="Times New Roman" panose="02020603050405020304" pitchFamily="18" charset="0"/>
              <a:ea typeface="ＭＳ ゴシック" panose="020B0609070205080204" pitchFamily="49" charset="-128"/>
              <a:cs typeface="+mj-cs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8D1BCA6-67E1-1660-7445-17C9714C7E17}"/>
              </a:ext>
            </a:extLst>
          </p:cNvPr>
          <p:cNvSpPr txBox="1"/>
          <p:nvPr/>
        </p:nvSpPr>
        <p:spPr>
          <a:xfrm>
            <a:off x="7647207" y="1222972"/>
            <a:ext cx="24721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kern="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+mj-cs"/>
              </a:rPr>
              <a:t>WC change at POY3</a:t>
            </a:r>
            <a:endParaRPr lang="ja-JP" altLang="en-US" sz="2000" b="1" kern="0" dirty="0" err="1">
              <a:solidFill>
                <a:srgbClr val="000000"/>
              </a:solidFill>
              <a:latin typeface="Times New Roman" panose="02020603050405020304" pitchFamily="18" charset="0"/>
              <a:ea typeface="ＭＳ ゴシック" panose="020B0609070205080204" pitchFamily="49" charset="-128"/>
              <a:cs typeface="+mj-cs"/>
            </a:endParaRPr>
          </a:p>
        </p:txBody>
      </p:sp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50F4B3B3-3843-4E07-889B-59A96741A8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4663337"/>
              </p:ext>
            </p:extLst>
          </p:nvPr>
        </p:nvGraphicFramePr>
        <p:xfrm>
          <a:off x="5958200" y="2515477"/>
          <a:ext cx="4748537" cy="35802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391E12B-B45F-26D2-D4C3-5A5AD0DE828C}"/>
              </a:ext>
            </a:extLst>
          </p:cNvPr>
          <p:cNvSpPr txBox="1"/>
          <p:nvPr/>
        </p:nvSpPr>
        <p:spPr>
          <a:xfrm>
            <a:off x="1257400" y="1912956"/>
            <a:ext cx="388861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altLang="ja-JP" sz="1600" dirty="0"/>
              <a:t> </a:t>
            </a:r>
            <a:r>
              <a:rPr lang="en-US" altLang="ja-JP" sz="16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+mj-cs"/>
              </a:rPr>
              <a:t>VFA change −13%</a:t>
            </a:r>
          </a:p>
          <a:p>
            <a:r>
              <a:rPr lang="en-US" altLang="ja-JP" sz="16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+mj-cs"/>
              </a:rPr>
              <a:t> (HR, 3.58; 95%CI, 1.17–10.94; p = 0.025)</a:t>
            </a:r>
            <a:endParaRPr lang="ja-JP" altLang="en-US" sz="1600" kern="0" dirty="0">
              <a:solidFill>
                <a:srgbClr val="000000"/>
              </a:solidFill>
              <a:latin typeface="Times New Roman" panose="02020603050405020304" pitchFamily="18" charset="0"/>
              <a:ea typeface="ＭＳ ゴシック" panose="020B0609070205080204" pitchFamily="49" charset="-128"/>
              <a:cs typeface="+mj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6AA68D1-477D-782D-D86F-4EBEBD749D7F}"/>
              </a:ext>
            </a:extLst>
          </p:cNvPr>
          <p:cNvSpPr txBox="1"/>
          <p:nvPr/>
        </p:nvSpPr>
        <p:spPr>
          <a:xfrm>
            <a:off x="6893394" y="1912956"/>
            <a:ext cx="3888612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altLang="ja-JP" sz="1600" dirty="0"/>
              <a:t> </a:t>
            </a:r>
            <a:r>
              <a:rPr lang="en-US" altLang="ja-JP" sz="16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+mj-cs"/>
              </a:rPr>
              <a:t>WC change −5%</a:t>
            </a:r>
          </a:p>
          <a:p>
            <a:r>
              <a:rPr lang="en-US" altLang="ja-JP" sz="16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+mj-cs"/>
              </a:rPr>
              <a:t> (</a:t>
            </a:r>
            <a:r>
              <a:rPr lang="it-IT" altLang="ja-JP" sz="16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+mj-cs"/>
              </a:rPr>
              <a:t>HR, 3.82; 95% CI: 1.25–11.7; p = 0.019</a:t>
            </a:r>
            <a:r>
              <a:rPr lang="en-US" altLang="ja-JP" sz="16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+mj-cs"/>
              </a:rPr>
              <a:t>)</a:t>
            </a:r>
            <a:endParaRPr lang="ja-JP" altLang="en-US" sz="1600" kern="0" dirty="0">
              <a:solidFill>
                <a:srgbClr val="000000"/>
              </a:solidFill>
              <a:latin typeface="Times New Roman" panose="02020603050405020304" pitchFamily="18" charset="0"/>
              <a:ea typeface="ＭＳ ゴシック" panose="020B0609070205080204" pitchFamily="49" charset="-128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900170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94</Words>
  <Application>Microsoft Office PowerPoint</Application>
  <PresentationFormat>ワイド画面</PresentationFormat>
  <Paragraphs>1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upplementary Figure 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伊坂　哲哉</dc:creator>
  <cp:lastModifiedBy>伊坂　哲哉</cp:lastModifiedBy>
  <cp:revision>8</cp:revision>
  <dcterms:created xsi:type="dcterms:W3CDTF">2024-11-17T06:29:39Z</dcterms:created>
  <dcterms:modified xsi:type="dcterms:W3CDTF">2025-01-09T04:05:05Z</dcterms:modified>
</cp:coreProperties>
</file>